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DFF"/>
    <a:srgbClr val="FF9300"/>
    <a:srgbClr val="FF2600"/>
    <a:srgbClr val="0432FF"/>
    <a:srgbClr val="AB7942"/>
    <a:srgbClr val="FF40FF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49"/>
    <p:restoredTop sz="96838"/>
  </p:normalViewPr>
  <p:slideViewPr>
    <p:cSldViewPr snapToGrid="0" snapToObjects="1">
      <p:cViewPr>
        <p:scale>
          <a:sx n="158" d="100"/>
          <a:sy n="158" d="100"/>
        </p:scale>
        <p:origin x="148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F7862C-DECF-1245-B4B2-0A20E6C4980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4DDE7F-DF32-4448-A65F-B1B645076E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628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289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50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7339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300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692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4252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40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880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095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278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102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A08E0-5F0D-3E41-8896-14DFCFCF97ED}" type="datetimeFigureOut">
              <a:rPr kumimoji="1" lang="ja-JP" altLang="en-US" smtClean="0"/>
              <a:t>2021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B5A89-F777-EB4A-A637-2A5391C69D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46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91119E2-032C-BF41-9DE3-9E5A14AF0265}"/>
              </a:ext>
            </a:extLst>
          </p:cNvPr>
          <p:cNvSpPr txBox="1"/>
          <p:nvPr/>
        </p:nvSpPr>
        <p:spPr>
          <a:xfrm>
            <a:off x="1218229" y="840658"/>
            <a:ext cx="44664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cs typeface="Arial"/>
              </a:rPr>
              <a:t>S1 Table. </a:t>
            </a:r>
            <a:r>
              <a:rPr lang="en-US" altLang="ja-JP" sz="1200" dirty="0">
                <a:latin typeface="Arial"/>
                <a:cs typeface="Arial"/>
              </a:rPr>
              <a:t>Provirus, Tax mRNA, and M-Sec mRNA in human CD3</a:t>
            </a:r>
            <a:r>
              <a:rPr lang="en-US" altLang="ja-JP" sz="1200" baseline="30000" dirty="0">
                <a:latin typeface="Arial"/>
                <a:cs typeface="Arial"/>
              </a:rPr>
              <a:t>+</a:t>
            </a:r>
            <a:r>
              <a:rPr lang="en-US" altLang="ja-JP" sz="1200" dirty="0">
                <a:latin typeface="Arial"/>
                <a:cs typeface="Arial"/>
              </a:rPr>
              <a:t> cells of MT-2-inoculated humanized mice</a:t>
            </a:r>
            <a:endParaRPr kumimoji="1" lang="en-US" altLang="ja-JP" sz="1200" dirty="0">
              <a:latin typeface="Arial"/>
              <a:cs typeface="Arial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A87E5B0A-3965-9749-81CD-DB4FEDA8F31A}"/>
              </a:ext>
            </a:extLst>
          </p:cNvPr>
          <p:cNvCxnSpPr/>
          <p:nvPr/>
        </p:nvCxnSpPr>
        <p:spPr>
          <a:xfrm>
            <a:off x="1184499" y="1304892"/>
            <a:ext cx="45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EC1A0711-25B8-C243-A94C-A3CF4DAF6E4B}"/>
              </a:ext>
            </a:extLst>
          </p:cNvPr>
          <p:cNvCxnSpPr/>
          <p:nvPr/>
        </p:nvCxnSpPr>
        <p:spPr>
          <a:xfrm>
            <a:off x="1184499" y="2952292"/>
            <a:ext cx="45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1EDE20F-3DF6-F040-A72C-DC3D69F7A63D}"/>
              </a:ext>
            </a:extLst>
          </p:cNvPr>
          <p:cNvSpPr txBox="1"/>
          <p:nvPr/>
        </p:nvSpPr>
        <p:spPr>
          <a:xfrm>
            <a:off x="1152476" y="1318846"/>
            <a:ext cx="567783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02DDC594-52DC-FF46-88F3-F31FB90D2AFD}"/>
              </a:ext>
            </a:extLst>
          </p:cNvPr>
          <p:cNvCxnSpPr/>
          <p:nvPr/>
        </p:nvCxnSpPr>
        <p:spPr>
          <a:xfrm>
            <a:off x="1184499" y="1741099"/>
            <a:ext cx="45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CDBCDB6-D71C-484D-BAF7-8F7112292C98}"/>
              </a:ext>
            </a:extLst>
          </p:cNvPr>
          <p:cNvSpPr txBox="1"/>
          <p:nvPr/>
        </p:nvSpPr>
        <p:spPr>
          <a:xfrm>
            <a:off x="2827101" y="1318846"/>
            <a:ext cx="1418978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x mRNA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elative to mouse #1)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±2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31±12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97±37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93E2929-3415-CF45-97E4-57CB90B5A429}"/>
              </a:ext>
            </a:extLst>
          </p:cNvPr>
          <p:cNvSpPr txBox="1"/>
          <p:nvPr/>
        </p:nvSpPr>
        <p:spPr>
          <a:xfrm>
            <a:off x="4300636" y="1318846"/>
            <a:ext cx="1418979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-Sec mRNA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relative to mouse #3)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t detected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t detected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.4±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C1F0CD9-92D5-224F-BF7E-8384796653CF}"/>
              </a:ext>
            </a:extLst>
          </p:cNvPr>
          <p:cNvSpPr txBox="1"/>
          <p:nvPr/>
        </p:nvSpPr>
        <p:spPr>
          <a:xfrm>
            <a:off x="1739645" y="1318846"/>
            <a:ext cx="1079142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virus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opy/100 cells)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</a:p>
          <a:p>
            <a:pPr algn="ctr"/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7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A624F42-89FD-6140-9879-9AB35AC8026F}"/>
              </a:ext>
            </a:extLst>
          </p:cNvPr>
          <p:cNvSpPr txBox="1"/>
          <p:nvPr/>
        </p:nvSpPr>
        <p:spPr>
          <a:xfrm>
            <a:off x="1169718" y="3065383"/>
            <a:ext cx="461209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Humanized mice (n = 4) were inoculated intra-peritoneally with the irradiated control MT-2 cells. After 4 weeks, cells in peripheral blood and spleen were collected, and subjected to MACS enrichment of human CD3</a:t>
            </a:r>
            <a:r>
              <a:rPr lang="en-US" altLang="ja-JP" sz="12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+</a:t>
            </a:r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cells (</a:t>
            </a:r>
            <a:r>
              <a:rPr lang="en-US" altLang="ja-JP" sz="12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iltenyi</a:t>
            </a:r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Biotech) followed by isolation of genomic DNA or total RNA. The numbers of </a:t>
            </a:r>
            <a:r>
              <a:rPr lang="en-US" altLang="ja-JP" sz="12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roviral</a:t>
            </a:r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copies (qPCR), and the levels of Tax- and M-Sec mRNA (</a:t>
            </a:r>
            <a:r>
              <a:rPr lang="en-US" altLang="ja-JP" sz="12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qRT</a:t>
            </a:r>
            <a:r>
              <a:rPr lang="en-US" altLang="ja-JP" sz="12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-PCR) are shown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In this experiment, to exclude the inoculated MT-2 cells and analyze only human T cells reconstituted in mice, CD3 (but not CD4) was used as the marker because MT-2 cells are positive for CD4 but negative for CD3 (</a:t>
            </a:r>
            <a:r>
              <a:rPr lang="en" altLang="ja-JP" sz="1200" dirty="0">
                <a:solidFill>
                  <a:srgbClr val="19191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mano R, Wu X, Wang Y, Oppenheim JJ, Chen X. Characterization of MT-2 cells as a human regulatory T cell-like cell line. Cell </a:t>
            </a:r>
            <a:r>
              <a:rPr lang="en" altLang="ja-JP" sz="1200" dirty="0" err="1">
                <a:solidFill>
                  <a:srgbClr val="19191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" altLang="ja-JP" sz="1200" dirty="0">
                <a:solidFill>
                  <a:srgbClr val="19191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mmunol. 2015;12: 780-782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)</a:t>
            </a:r>
            <a:endParaRPr lang="en-US" altLang="ja-JP" sz="12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9474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53</TotalTime>
  <Words>223</Words>
  <Application>Microsoft Macintosh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410</cp:revision>
  <cp:lastPrinted>2021-07-12T22:39:11Z</cp:lastPrinted>
  <dcterms:created xsi:type="dcterms:W3CDTF">2020-08-06T22:58:35Z</dcterms:created>
  <dcterms:modified xsi:type="dcterms:W3CDTF">2021-07-14T02:25:52Z</dcterms:modified>
</cp:coreProperties>
</file>